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>
      <p:cViewPr varScale="1">
        <p:scale>
          <a:sx n="91" d="100"/>
          <a:sy n="91" d="100"/>
        </p:scale>
        <p:origin x="2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37B0C9-90CC-33FF-7192-96A423F5EF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B170631-7B4A-1D60-9DCF-7966B32EC1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2F45F5-8E7B-205D-15D9-E59BA2B37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1DC1FD-88EA-ABC5-6868-1CCDE82B9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987C029-DD05-4C25-9F33-FF9474C3E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364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053721-BD1B-9956-78FA-53A669B0C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C003CFC-B837-617C-445E-8C3EAAE6C3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358F158-A1CD-0BE6-40E6-1ECA165E8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1971D8-AB52-A7C0-8523-8A51E4896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E39F15-BE27-ADB0-10C7-800B868FD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3518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8B26A57-737E-8B7F-005D-8F2B4FAA35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7DFBDD8-9E31-28A8-A214-35BB69C6E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EDEC2F-91A5-FA4A-837B-6D71A041F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9DE229-B9FE-DCD3-E3FF-A06D106DF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7C00F8-F227-8215-A93C-EFB802470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6713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81F067-9096-24D5-C2B7-A48CB74CA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D4AF658-2DF9-D509-278E-305230901F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F2C2FC-ECED-2FE4-6314-7E1ACF6C1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7FCFFDE-1112-B0FC-E67F-8AA0E25A5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885F39-A8D1-52A5-E24D-E2007443A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0249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CAEE6A-B292-E0D0-3588-EF9B5C1E06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51092A4-A24E-B1B6-692B-19B99652D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C61001-6985-F9F3-DA94-0879E1A2C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00F80A-9337-1474-861C-11F4E923A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F99CC32-3540-638B-5BA0-2892D5C75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07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D580A6-3F22-3684-21CF-059583B012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BB714BA-CA13-F5FD-E3F3-4C22C73F08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A174B27-C430-F787-64BD-3BBB1AD76D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59086C-DDE5-A9DA-D714-91B7C0069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0E8ACA7-6B43-9C72-0474-D7DC98374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7E25489-9613-8B60-10F6-37ABEE95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1691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F63D44-D3C9-F311-0D1E-104DAC24B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7D32198-B700-7EF3-4401-21A3932A7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BB91E4D-D9E0-D8B1-0726-0751D1B0C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78600CC-7087-CB28-C322-9ECF92056A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3396A40-A995-B5A0-3716-1C5B136BFD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40F7AFB-9E70-8F85-AD32-A325C81D4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4ECE1D0-2159-47E3-8B51-A8A269A72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72170ED-BB37-32C9-8A8C-28C501719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8120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4C9C0A-89DD-9995-4604-8916F29D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667708A-1DEC-76D5-79C6-B9A70C153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0720167-8760-E54E-D579-A6CA85995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D2A1081-9F5A-66FC-ED8D-2F0957550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2405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3A45AFE-D0C3-79A2-B35B-3E85167F6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483EFB9-8584-403E-96F9-C08535D4C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4578EFB-0AEB-34A4-FA36-25E8A2961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030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DABB3C-6BCE-D485-EF91-B48671EF21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1851A6A-27F3-B0BD-9D35-0155914B82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D3B8ED9-F16B-CB6F-424E-6FD71369CD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10F3DBE-34ED-47EB-8A81-B6CA2AD2D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34A035-8E41-CA96-161F-698F96951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FD4711A-5E3A-5BE5-EF3C-83ED5C80B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8722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74FA7E-BA0E-6D92-95F6-27A178A6B1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3F44768-EF7B-25C6-2853-E06D98314A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355C827-FEF0-D0F3-E4D1-F6313B086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400E398-5F08-70C2-556B-4D9F83337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9A9D02F-2290-7396-68FD-9BD21B8BC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E6E7E33-CF1A-C4D3-98D6-8DB1098B2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2393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E665F57-209D-2195-654D-21A9AEFC3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4DAAAF5-00F6-CCCD-C029-B956DD8D06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35B8E4F-EDCA-00B1-FE8E-0C97B36D84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07D45DA-7510-8824-965B-2AD3E1971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0711744-FC1E-C21E-19DA-523C0512D6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950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0B684F0-C7DE-6466-0CBE-691BB652C04E}"/>
              </a:ext>
            </a:extLst>
          </p:cNvPr>
          <p:cNvSpPr txBox="1"/>
          <p:nvPr/>
        </p:nvSpPr>
        <p:spPr>
          <a:xfrm>
            <a:off x="1510225" y="5343307"/>
            <a:ext cx="91715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Correlation Analyse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cores of all questionnaires, as well as age and body mass index (BMI) were analyzed regarding possible associations at the 12-month follow-up. Age and BMI weakly correlated to the scores of the questionnaires, indicating that these characteristics had little impact on the results. Patient health questionnaire-9 (PHQ-9), generalized anxiety disorder 7 (GAD-7), perceived stress scale (PSS-10) and the posttraumatic symptom scale 10 (PTSS-10) displayed strong positive correlations between each other in both groups, as well as negative correlations with the FACIT-F (as a lower score indicates more severe fatigue in the test). Correlations to the EQ5D-5L index were weak for all questionnaires with the exception if the FACIT-F having a moderate positive correlation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AC822042-81C2-2299-5205-733E4DF796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0225" y="74192"/>
            <a:ext cx="9171547" cy="5160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4664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 Herrmann</dc:creator>
  <cp:lastModifiedBy>Johannes Herrmann</cp:lastModifiedBy>
  <cp:revision>2</cp:revision>
  <dcterms:created xsi:type="dcterms:W3CDTF">2023-04-16T20:01:39Z</dcterms:created>
  <dcterms:modified xsi:type="dcterms:W3CDTF">2023-04-16T20:04:34Z</dcterms:modified>
</cp:coreProperties>
</file>